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7559675" cy="10691813"/>
  <p:notesSz cx="6800850" cy="99329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00400" cy="9932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" name="AutoShape 1"/>
          <p:cNvSpPr/>
          <p:nvPr/>
        </p:nvSpPr>
        <p:spPr>
          <a:xfrm>
            <a:off x="0" y="0"/>
            <a:ext cx="6799320" cy="9931320"/>
          </a:xfrm>
          <a:custGeom>
            <a:avLst/>
            <a:gdLst>
              <a:gd name="textAreaLeft" fmla="*/ 360 w 6799320"/>
              <a:gd name="textAreaRight" fmla="*/ 6798960 w 6799320"/>
              <a:gd name="textAreaTop" fmla="*/ 360 h 9931320"/>
              <a:gd name="textAreaBottom" fmla="*/ 9930960 h 9931320"/>
            </a:gdLst>
            <a:ahLst/>
            <a:rect l="textAreaLeft" t="textAreaTop" r="textAreaRight" b="textAreaBottom"/>
            <a:pathLst>
              <a:path w="21600" h="31549">
                <a:moveTo>
                  <a:pt x="4" y="0"/>
                </a:moveTo>
                <a:arcTo wR="4" hR="4" stAng="16200000" swAng="-5400000"/>
                <a:lnTo>
                  <a:pt x="0" y="31545"/>
                </a:lnTo>
                <a:arcTo wR="4" hR="4" stAng="10800000" swAng="-5400000"/>
                <a:lnTo>
                  <a:pt x="21596" y="31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5680" rIns="85680" tIns="42840" bIns="4284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" name="PlaceHolder 1"/>
          <p:cNvSpPr>
            <a:spLocks noGrp="1"/>
          </p:cNvSpPr>
          <p:nvPr>
            <p:ph type="sldImg"/>
          </p:nvPr>
        </p:nvSpPr>
        <p:spPr>
          <a:xfrm>
            <a:off x="2082600" y="754200"/>
            <a:ext cx="2631960" cy="3720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 type="body"/>
          </p:nvPr>
        </p:nvSpPr>
        <p:spPr>
          <a:xfrm>
            <a:off x="680760" y="4716000"/>
            <a:ext cx="5437080" cy="446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PlaceHolder 3"/>
          <p:cNvSpPr>
            <a:spLocks noGrp="1"/>
          </p:cNvSpPr>
          <p:nvPr>
            <p:ph type="hdr"/>
          </p:nvPr>
        </p:nvSpPr>
        <p:spPr>
          <a:xfrm>
            <a:off x="-360" y="-360"/>
            <a:ext cx="2948040" cy="493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" name="PlaceHolder 4"/>
          <p:cNvSpPr>
            <a:spLocks noGrp="1"/>
          </p:cNvSpPr>
          <p:nvPr>
            <p:ph type="dt" idx="4"/>
          </p:nvPr>
        </p:nvSpPr>
        <p:spPr>
          <a:xfrm>
            <a:off x="3847680" y="-360"/>
            <a:ext cx="2948040" cy="493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" name="PlaceHolder 5"/>
          <p:cNvSpPr>
            <a:spLocks noGrp="1"/>
          </p:cNvSpPr>
          <p:nvPr>
            <p:ph type="ftr" idx="5"/>
          </p:nvPr>
        </p:nvSpPr>
        <p:spPr>
          <a:xfrm>
            <a:off x="-360" y="9434160"/>
            <a:ext cx="2948040" cy="493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" name="PlaceHolder 6"/>
          <p:cNvSpPr>
            <a:spLocks noGrp="1"/>
          </p:cNvSpPr>
          <p:nvPr>
            <p:ph type="sldNum" idx="6"/>
          </p:nvPr>
        </p:nvSpPr>
        <p:spPr>
          <a:xfrm>
            <a:off x="3847680" y="9434160"/>
            <a:ext cx="2948040" cy="493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93000"/>
              </a:lnSpc>
              <a:buNone/>
              <a:tabLst>
                <a:tab algn="l" pos="0"/>
                <a:tab algn="l" pos="428760"/>
                <a:tab algn="l" pos="857160"/>
                <a:tab algn="l" pos="1285920"/>
                <a:tab algn="l" pos="1714680"/>
                <a:tab algn="l" pos="2143080"/>
                <a:tab algn="l" pos="2573280"/>
                <a:tab algn="l" pos="3002040"/>
                <a:tab algn="l" pos="3430440"/>
                <a:tab algn="l" pos="3859200"/>
                <a:tab algn="l" pos="4287960"/>
                <a:tab algn="l" pos="4716360"/>
                <a:tab algn="l" pos="5146560"/>
                <a:tab algn="l" pos="5575320"/>
                <a:tab algn="l" pos="6004080"/>
                <a:tab algn="l" pos="6432480"/>
                <a:tab algn="l" pos="6861240"/>
                <a:tab algn="l" pos="7289640"/>
                <a:tab algn="l" pos="7719840"/>
                <a:tab algn="l" pos="8148600"/>
                <a:tab algn="l" pos="857736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300" spc="-1" strike="noStrike">
                <a:solidFill>
                  <a:srgbClr val="000000"/>
                </a:solidFill>
                <a:latin typeface="Times New Roman"/>
                <a:ea typeface="MS PGothic"/>
              </a:defRPr>
            </a:lvl1pPr>
          </a:lstStyle>
          <a:p>
            <a:pPr indent="0" algn="r">
              <a:lnSpc>
                <a:spcPct val="93000"/>
              </a:lnSpc>
              <a:buNone/>
              <a:tabLst>
                <a:tab algn="l" pos="0"/>
                <a:tab algn="l" pos="428760"/>
                <a:tab algn="l" pos="857160"/>
                <a:tab algn="l" pos="1285920"/>
                <a:tab algn="l" pos="1714680"/>
                <a:tab algn="l" pos="2143080"/>
                <a:tab algn="l" pos="2573280"/>
                <a:tab algn="l" pos="3002040"/>
                <a:tab algn="l" pos="3430440"/>
                <a:tab algn="l" pos="3859200"/>
                <a:tab algn="l" pos="4287960"/>
                <a:tab algn="l" pos="4716360"/>
                <a:tab algn="l" pos="5146560"/>
                <a:tab algn="l" pos="5575320"/>
                <a:tab algn="l" pos="6004080"/>
                <a:tab algn="l" pos="6432480"/>
                <a:tab algn="l" pos="6861240"/>
                <a:tab algn="l" pos="7289640"/>
                <a:tab algn="l" pos="7719840"/>
                <a:tab algn="l" pos="8148600"/>
                <a:tab algn="l" pos="857736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2D12BB66-D334-4076-9B0E-19FD9E781454}" type="slidenum">
              <a:rPr b="0" lang="en-US" sz="1300" spc="-1" strike="noStrike">
                <a:solidFill>
                  <a:srgbClr val="000000"/>
                </a:solidFill>
                <a:latin typeface="Times New Roman"/>
                <a:ea typeface="MS PGothic"/>
              </a:rPr>
              <a:t>&lt;number&gt;</a:t>
            </a:fld>
            <a:endParaRPr b="0" lang="en-US" sz="13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Rectangle 7"/>
          <p:cNvSpPr/>
          <p:nvPr/>
        </p:nvSpPr>
        <p:spPr>
          <a:xfrm>
            <a:off x="3848040" y="9434520"/>
            <a:ext cx="29480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3000"/>
              </a:lnSpc>
              <a:tabLst>
                <a:tab algn="l" pos="0"/>
                <a:tab algn="l" pos="428760"/>
                <a:tab algn="l" pos="857160"/>
                <a:tab algn="l" pos="1285920"/>
                <a:tab algn="l" pos="1714680"/>
                <a:tab algn="l" pos="2143080"/>
                <a:tab algn="l" pos="2571840"/>
                <a:tab algn="l" pos="3000240"/>
                <a:tab algn="l" pos="3429000"/>
                <a:tab algn="l" pos="3859200"/>
                <a:tab algn="l" pos="4287960"/>
                <a:tab algn="l" pos="4716360"/>
                <a:tab algn="l" pos="5145120"/>
                <a:tab algn="l" pos="5573880"/>
                <a:tab algn="l" pos="6002280"/>
                <a:tab algn="l" pos="6431040"/>
                <a:tab algn="l" pos="6859440"/>
                <a:tab algn="l" pos="7288200"/>
                <a:tab algn="l" pos="7718400"/>
                <a:tab algn="l" pos="8148600"/>
                <a:tab algn="l" pos="857736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B3C6283D-32B8-4897-8C23-429547054721}" type="slidenum">
              <a:rPr b="0" lang="en-US" sz="1300" spc="-1" strike="noStrike">
                <a:solidFill>
                  <a:srgbClr val="000000"/>
                </a:solidFill>
                <a:latin typeface="Times New Roman"/>
                <a:ea typeface="MS PGothic"/>
              </a:rPr>
              <a:t>&lt;number&gt;</a:t>
            </a:fld>
            <a:endParaRPr b="0" lang="en-US" sz="13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0" name="PlaceHolder 1"/>
          <p:cNvSpPr>
            <a:spLocks noGrp="1"/>
          </p:cNvSpPr>
          <p:nvPr>
            <p:ph type="sldImg"/>
          </p:nvPr>
        </p:nvSpPr>
        <p:spPr>
          <a:xfrm>
            <a:off x="2082960" y="754200"/>
            <a:ext cx="2633400" cy="3724200"/>
          </a:xfrm>
          <a:prstGeom prst="rect">
            <a:avLst/>
          </a:prstGeom>
          <a:ln w="0">
            <a:noFill/>
          </a:ln>
        </p:spPr>
      </p:sp>
      <p:sp>
        <p:nvSpPr>
          <p:cNvPr id="71" name="PlaceHolder 2"/>
          <p:cNvSpPr>
            <a:spLocks noGrp="1"/>
          </p:cNvSpPr>
          <p:nvPr>
            <p:ph type="body"/>
          </p:nvPr>
        </p:nvSpPr>
        <p:spPr>
          <a:xfrm>
            <a:off x="680760" y="4716360"/>
            <a:ext cx="5437080" cy="4469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ja-JP" sz="1200" spc="-1" strike="noStrike">
              <a:solidFill>
                <a:srgbClr val="000000"/>
              </a:solidFill>
              <a:latin typeface="Times New Roman"/>
              <a:ea typeface="MS PGothic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6593F2-6A32-429B-B696-B0607A91DBB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68040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78000" y="6180120"/>
            <a:ext cx="68040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DF8A59-368E-456F-BFA6-9F1C2E14A38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78000" y="618012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864600" y="618012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535D44-C57E-4C37-BA9D-747929965A0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678400" y="249516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979160" y="249516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78000" y="618012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678400" y="618012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979160" y="618012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023D5C-32E5-421E-9506-09F16F12CD9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78000" y="2495160"/>
            <a:ext cx="6804000" cy="7054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26EF06-C2C0-40B1-8E96-D16DA3494E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680400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5CB907-5C01-47AF-B9B4-ED020D1773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B2AFDA-5454-4CC6-9E7D-39121920B7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098A06-66FC-4DB4-AA07-A6D500BEB8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78000" y="428400"/>
            <a:ext cx="6804000" cy="8256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E4116D-2DE0-4CEF-B8B8-9DBADC4C1A0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78000" y="618012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468340-A00E-45BF-9E14-E64CE3FF14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864600" y="618012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ACC393-D9D1-4CDE-9AB6-A10E6F0059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78000" y="6180120"/>
            <a:ext cx="68040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936207-D6CB-499C-ADB0-7E9B881F3E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78000" y="2495160"/>
            <a:ext cx="680400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77640" y="9909000"/>
            <a:ext cx="1763640" cy="5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582640" y="9909000"/>
            <a:ext cx="2393640" cy="5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418000" y="9909000"/>
            <a:ext cx="1764000" cy="5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Arial"/>
                <a:ea typeface="MS PGothic"/>
              </a:defRPr>
            </a:lvl1pPr>
          </a:lstStyle>
          <a:p>
            <a:pPr indent="0" algn="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A31F0DA-3D9F-4F25-A15B-ABD8F710CAB6}" type="slidenum">
              <a:rPr b="0" lang="en-US" sz="1200" spc="-1" strike="noStrike">
                <a:solidFill>
                  <a:srgbClr val="898989"/>
                </a:solidFill>
                <a:latin typeface="Arial"/>
                <a:ea typeface="MS PGothic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図 4" descr="mouse_all_art6_GC.png"/>
          <p:cNvPicPr/>
          <p:nvPr/>
        </p:nvPicPr>
        <p:blipFill>
          <a:blip r:embed="rId1"/>
          <a:stretch/>
        </p:blipFill>
        <p:spPr>
          <a:xfrm>
            <a:off x="352440" y="954000"/>
            <a:ext cx="3313080" cy="3311640"/>
          </a:xfrm>
          <a:prstGeom prst="rect">
            <a:avLst/>
          </a:prstGeom>
          <a:ln w="0">
            <a:noFill/>
          </a:ln>
        </p:spPr>
      </p:pic>
      <p:pic>
        <p:nvPicPr>
          <p:cNvPr id="50" name="図 5" descr="mouse_all_complart_GC.png"/>
          <p:cNvPicPr/>
          <p:nvPr/>
        </p:nvPicPr>
        <p:blipFill>
          <a:blip r:embed="rId2"/>
          <a:stretch/>
        </p:blipFill>
        <p:spPr>
          <a:xfrm>
            <a:off x="3995640" y="954000"/>
            <a:ext cx="3313080" cy="3311640"/>
          </a:xfrm>
          <a:prstGeom prst="rect">
            <a:avLst/>
          </a:prstGeom>
          <a:ln w="0">
            <a:noFill/>
          </a:ln>
        </p:spPr>
      </p:pic>
      <p:pic>
        <p:nvPicPr>
          <p:cNvPr id="51" name="図 4" descr="mouse_nonCpG_art0_GC.png"/>
          <p:cNvPicPr/>
          <p:nvPr/>
        </p:nvPicPr>
        <p:blipFill>
          <a:blip r:embed="rId3"/>
          <a:stretch/>
        </p:blipFill>
        <p:spPr>
          <a:xfrm>
            <a:off x="3995640" y="4842000"/>
            <a:ext cx="3313080" cy="3313080"/>
          </a:xfrm>
          <a:prstGeom prst="rect">
            <a:avLst/>
          </a:prstGeom>
          <a:ln w="0">
            <a:noFill/>
          </a:ln>
        </p:spPr>
      </p:pic>
      <p:pic>
        <p:nvPicPr>
          <p:cNvPr id="52" name="図 5" descr="mouse_CpG_art0_GC.png"/>
          <p:cNvPicPr/>
          <p:nvPr/>
        </p:nvPicPr>
        <p:blipFill>
          <a:blip r:embed="rId4"/>
          <a:stretch/>
        </p:blipFill>
        <p:spPr>
          <a:xfrm>
            <a:off x="322200" y="4842000"/>
            <a:ext cx="3313080" cy="3313080"/>
          </a:xfrm>
          <a:prstGeom prst="rect">
            <a:avLst/>
          </a:prstGeom>
          <a:ln w="0">
            <a:noFill/>
          </a:ln>
        </p:spPr>
      </p:pic>
      <p:sp>
        <p:nvSpPr>
          <p:cNvPr id="53" name="テキスト ボックス 6"/>
          <p:cNvSpPr/>
          <p:nvPr/>
        </p:nvSpPr>
        <p:spPr>
          <a:xfrm>
            <a:off x="254520" y="4626000"/>
            <a:ext cx="400320" cy="43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C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" name="テキスト ボックス 7"/>
          <p:cNvSpPr/>
          <p:nvPr/>
        </p:nvSpPr>
        <p:spPr>
          <a:xfrm>
            <a:off x="3663000" y="4626000"/>
            <a:ext cx="400320" cy="43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D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5" name="テキスト ボックス 8"/>
          <p:cNvSpPr/>
          <p:nvPr/>
        </p:nvSpPr>
        <p:spPr>
          <a:xfrm>
            <a:off x="254520" y="880920"/>
            <a:ext cx="400320" cy="43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A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6" name="テキスト ボックス 9"/>
          <p:cNvSpPr/>
          <p:nvPr/>
        </p:nvSpPr>
        <p:spPr>
          <a:xfrm>
            <a:off x="3663000" y="880920"/>
            <a:ext cx="400320" cy="43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B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7" name="Rectangle 10"/>
          <p:cNvSpPr/>
          <p:nvPr/>
        </p:nvSpPr>
        <p:spPr>
          <a:xfrm>
            <a:off x="4427640" y="4842000"/>
            <a:ext cx="2808360" cy="3650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8" name="Rectangle 11"/>
          <p:cNvSpPr/>
          <p:nvPr/>
        </p:nvSpPr>
        <p:spPr>
          <a:xfrm>
            <a:off x="684360" y="4770360"/>
            <a:ext cx="2808000" cy="3650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9" name="Rectangle 12"/>
          <p:cNvSpPr/>
          <p:nvPr/>
        </p:nvSpPr>
        <p:spPr>
          <a:xfrm>
            <a:off x="4356000" y="880920"/>
            <a:ext cx="2808360" cy="36540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0" name="Rectangle 13"/>
          <p:cNvSpPr/>
          <p:nvPr/>
        </p:nvSpPr>
        <p:spPr>
          <a:xfrm>
            <a:off x="712800" y="954000"/>
            <a:ext cx="2808360" cy="36504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1" name="TextBox 14"/>
          <p:cNvSpPr/>
          <p:nvPr/>
        </p:nvSpPr>
        <p:spPr>
          <a:xfrm>
            <a:off x="971640" y="4021200"/>
            <a:ext cx="2120760" cy="29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log2(frequency ratio)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2" name="TextBox 15"/>
          <p:cNvSpPr/>
          <p:nvPr/>
        </p:nvSpPr>
        <p:spPr>
          <a:xfrm>
            <a:off x="4643280" y="4021200"/>
            <a:ext cx="2121120" cy="318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  <a:ea typeface="MS PGothic"/>
              </a:rPr>
              <a:t>2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(frequency ratio)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3" name="TextBox 16"/>
          <p:cNvSpPr/>
          <p:nvPr/>
        </p:nvSpPr>
        <p:spPr>
          <a:xfrm>
            <a:off x="971640" y="7910640"/>
            <a:ext cx="2120760" cy="318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  <a:ea typeface="MS PGothic"/>
              </a:rPr>
              <a:t>2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(frequency ratio)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4" name="TextBox 17"/>
          <p:cNvSpPr/>
          <p:nvPr/>
        </p:nvSpPr>
        <p:spPr>
          <a:xfrm>
            <a:off x="4643280" y="7908840"/>
            <a:ext cx="2121120" cy="318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log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  <a:ea typeface="MS PGothic"/>
              </a:rPr>
              <a:t>2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(frequency ratio)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5" name="TextBox 19"/>
          <p:cNvSpPr/>
          <p:nvPr/>
        </p:nvSpPr>
        <p:spPr>
          <a:xfrm rot="16200000">
            <a:off x="-926280" y="2458080"/>
            <a:ext cx="2494080" cy="29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Difference in GC content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6" name="TextBox 20"/>
          <p:cNvSpPr/>
          <p:nvPr/>
        </p:nvSpPr>
        <p:spPr>
          <a:xfrm rot="16200000">
            <a:off x="2745720" y="6345720"/>
            <a:ext cx="2493720" cy="29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Difference in GC content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7" name="TextBox 21"/>
          <p:cNvSpPr/>
          <p:nvPr/>
        </p:nvSpPr>
        <p:spPr>
          <a:xfrm rot="16200000">
            <a:off x="-925920" y="6345720"/>
            <a:ext cx="2493720" cy="29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Difference in GC content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8" name="TextBox 23"/>
          <p:cNvSpPr/>
          <p:nvPr/>
        </p:nvSpPr>
        <p:spPr>
          <a:xfrm rot="16200000">
            <a:off x="2745360" y="2458080"/>
            <a:ext cx="2494080" cy="29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Difference in GC content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5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23T09:27:06Z</dcterms:created>
  <dc:creator>Alexis Vandenbon</dc:creator>
  <dc:description/>
  <dc:language>en-US</dc:language>
  <cp:lastModifiedBy>alexvdb</cp:lastModifiedBy>
  <dcterms:modified xsi:type="dcterms:W3CDTF">2012-03-21T13:16:56Z</dcterms:modified>
  <cp:revision>218</cp:revision>
  <dc:subject/>
  <dc:title>スライド 1</dc:title>
</cp:coreProperties>
</file>